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5292725" cy="8459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DDCE"/>
    <a:srgbClr val="FFCFF2"/>
    <a:srgbClr val="FCB4C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6955" y="1384509"/>
            <a:ext cx="4498816" cy="2945260"/>
          </a:xfrm>
        </p:spPr>
        <p:txBody>
          <a:bodyPr anchor="b"/>
          <a:lstStyle>
            <a:lvl1pPr algn="ctr">
              <a:defRPr sz="347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1591" y="4443348"/>
            <a:ext cx="3969544" cy="2042490"/>
          </a:xfrm>
        </p:spPr>
        <p:txBody>
          <a:bodyPr/>
          <a:lstStyle>
            <a:lvl1pPr marL="0" indent="0" algn="ctr">
              <a:buNone/>
              <a:defRPr sz="1389"/>
            </a:lvl1pPr>
            <a:lvl2pPr marL="264617" indent="0" algn="ctr">
              <a:buNone/>
              <a:defRPr sz="1157"/>
            </a:lvl2pPr>
            <a:lvl3pPr marL="529233" indent="0" algn="ctr">
              <a:buNone/>
              <a:defRPr sz="1042"/>
            </a:lvl3pPr>
            <a:lvl4pPr marL="793850" indent="0" algn="ctr">
              <a:buNone/>
              <a:defRPr sz="925"/>
            </a:lvl4pPr>
            <a:lvl5pPr marL="1058465" indent="0" algn="ctr">
              <a:buNone/>
              <a:defRPr sz="925"/>
            </a:lvl5pPr>
            <a:lvl6pPr marL="1323084" indent="0" algn="ctr">
              <a:buNone/>
              <a:defRPr sz="925"/>
            </a:lvl6pPr>
            <a:lvl7pPr marL="1587699" indent="0" algn="ctr">
              <a:buNone/>
              <a:defRPr sz="925"/>
            </a:lvl7pPr>
            <a:lvl8pPr marL="1852315" indent="0" algn="ctr">
              <a:buNone/>
              <a:defRPr sz="925"/>
            </a:lvl8pPr>
            <a:lvl9pPr marL="2116932" indent="0" algn="ctr">
              <a:buNone/>
              <a:defRPr sz="925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9229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0236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87607" y="450406"/>
            <a:ext cx="1141244" cy="716928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3875" y="450406"/>
            <a:ext cx="3357572" cy="716928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1718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5855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120" y="2109076"/>
            <a:ext cx="4564975" cy="3519036"/>
          </a:xfrm>
        </p:spPr>
        <p:txBody>
          <a:bodyPr anchor="b"/>
          <a:lstStyle>
            <a:lvl1pPr>
              <a:defRPr sz="347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1120" y="5661403"/>
            <a:ext cx="4564975" cy="1850578"/>
          </a:xfrm>
        </p:spPr>
        <p:txBody>
          <a:bodyPr/>
          <a:lstStyle>
            <a:lvl1pPr marL="0" indent="0">
              <a:buNone/>
              <a:defRPr sz="1389">
                <a:solidFill>
                  <a:schemeClr val="tx1"/>
                </a:solidFill>
              </a:defRPr>
            </a:lvl1pPr>
            <a:lvl2pPr marL="264617" indent="0">
              <a:buNone/>
              <a:defRPr sz="1157">
                <a:solidFill>
                  <a:schemeClr val="tx1">
                    <a:tint val="75000"/>
                  </a:schemeClr>
                </a:solidFill>
              </a:defRPr>
            </a:lvl2pPr>
            <a:lvl3pPr marL="529233" indent="0">
              <a:buNone/>
              <a:defRPr sz="1042">
                <a:solidFill>
                  <a:schemeClr val="tx1">
                    <a:tint val="75000"/>
                  </a:schemeClr>
                </a:solidFill>
              </a:defRPr>
            </a:lvl3pPr>
            <a:lvl4pPr marL="793850" indent="0">
              <a:buNone/>
              <a:defRPr sz="925">
                <a:solidFill>
                  <a:schemeClr val="tx1">
                    <a:tint val="75000"/>
                  </a:schemeClr>
                </a:solidFill>
              </a:defRPr>
            </a:lvl4pPr>
            <a:lvl5pPr marL="1058465" indent="0">
              <a:buNone/>
              <a:defRPr sz="925">
                <a:solidFill>
                  <a:schemeClr val="tx1">
                    <a:tint val="75000"/>
                  </a:schemeClr>
                </a:solidFill>
              </a:defRPr>
            </a:lvl5pPr>
            <a:lvl6pPr marL="1323084" indent="0">
              <a:buNone/>
              <a:defRPr sz="925">
                <a:solidFill>
                  <a:schemeClr val="tx1">
                    <a:tint val="75000"/>
                  </a:schemeClr>
                </a:solidFill>
              </a:defRPr>
            </a:lvl6pPr>
            <a:lvl7pPr marL="1587699" indent="0">
              <a:buNone/>
              <a:defRPr sz="925">
                <a:solidFill>
                  <a:schemeClr val="tx1">
                    <a:tint val="75000"/>
                  </a:schemeClr>
                </a:solidFill>
              </a:defRPr>
            </a:lvl7pPr>
            <a:lvl8pPr marL="1852315" indent="0">
              <a:buNone/>
              <a:defRPr sz="925">
                <a:solidFill>
                  <a:schemeClr val="tx1">
                    <a:tint val="75000"/>
                  </a:schemeClr>
                </a:solidFill>
              </a:defRPr>
            </a:lvl8pPr>
            <a:lvl9pPr marL="2116932" indent="0">
              <a:buNone/>
              <a:defRPr sz="9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5988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3875" y="2252027"/>
            <a:ext cx="2249408" cy="536765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79442" y="2252027"/>
            <a:ext cx="2249408" cy="536765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2355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565" y="450406"/>
            <a:ext cx="4564975" cy="1635169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4565" y="2073825"/>
            <a:ext cx="2239070" cy="1016349"/>
          </a:xfrm>
        </p:spPr>
        <p:txBody>
          <a:bodyPr anchor="b"/>
          <a:lstStyle>
            <a:lvl1pPr marL="0" indent="0">
              <a:buNone/>
              <a:defRPr sz="1389" b="1"/>
            </a:lvl1pPr>
            <a:lvl2pPr marL="264617" indent="0">
              <a:buNone/>
              <a:defRPr sz="1157" b="1"/>
            </a:lvl2pPr>
            <a:lvl3pPr marL="529233" indent="0">
              <a:buNone/>
              <a:defRPr sz="1042" b="1"/>
            </a:lvl3pPr>
            <a:lvl4pPr marL="793850" indent="0">
              <a:buNone/>
              <a:defRPr sz="925" b="1"/>
            </a:lvl4pPr>
            <a:lvl5pPr marL="1058465" indent="0">
              <a:buNone/>
              <a:defRPr sz="925" b="1"/>
            </a:lvl5pPr>
            <a:lvl6pPr marL="1323084" indent="0">
              <a:buNone/>
              <a:defRPr sz="925" b="1"/>
            </a:lvl6pPr>
            <a:lvl7pPr marL="1587699" indent="0">
              <a:buNone/>
              <a:defRPr sz="925" b="1"/>
            </a:lvl7pPr>
            <a:lvl8pPr marL="1852315" indent="0">
              <a:buNone/>
              <a:defRPr sz="925" b="1"/>
            </a:lvl8pPr>
            <a:lvl9pPr marL="2116932" indent="0">
              <a:buNone/>
              <a:defRPr sz="925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565" y="3090173"/>
            <a:ext cx="2239070" cy="45451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79444" y="2073825"/>
            <a:ext cx="2250097" cy="1016349"/>
          </a:xfrm>
        </p:spPr>
        <p:txBody>
          <a:bodyPr anchor="b"/>
          <a:lstStyle>
            <a:lvl1pPr marL="0" indent="0">
              <a:buNone/>
              <a:defRPr sz="1389" b="1"/>
            </a:lvl1pPr>
            <a:lvl2pPr marL="264617" indent="0">
              <a:buNone/>
              <a:defRPr sz="1157" b="1"/>
            </a:lvl2pPr>
            <a:lvl3pPr marL="529233" indent="0">
              <a:buNone/>
              <a:defRPr sz="1042" b="1"/>
            </a:lvl3pPr>
            <a:lvl4pPr marL="793850" indent="0">
              <a:buNone/>
              <a:defRPr sz="925" b="1"/>
            </a:lvl4pPr>
            <a:lvl5pPr marL="1058465" indent="0">
              <a:buNone/>
              <a:defRPr sz="925" b="1"/>
            </a:lvl5pPr>
            <a:lvl6pPr marL="1323084" indent="0">
              <a:buNone/>
              <a:defRPr sz="925" b="1"/>
            </a:lvl6pPr>
            <a:lvl7pPr marL="1587699" indent="0">
              <a:buNone/>
              <a:defRPr sz="925" b="1"/>
            </a:lvl7pPr>
            <a:lvl8pPr marL="1852315" indent="0">
              <a:buNone/>
              <a:defRPr sz="925" b="1"/>
            </a:lvl8pPr>
            <a:lvl9pPr marL="2116932" indent="0">
              <a:buNone/>
              <a:defRPr sz="925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79444" y="3090173"/>
            <a:ext cx="2250097" cy="45451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959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415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712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564" y="563988"/>
            <a:ext cx="1707042" cy="1973950"/>
          </a:xfrm>
        </p:spPr>
        <p:txBody>
          <a:bodyPr anchor="b"/>
          <a:lstStyle>
            <a:lvl1pPr>
              <a:defRPr sz="185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50098" y="1218056"/>
            <a:ext cx="2679442" cy="6011932"/>
          </a:xfrm>
        </p:spPr>
        <p:txBody>
          <a:bodyPr/>
          <a:lstStyle>
            <a:lvl1pPr>
              <a:defRPr sz="1853"/>
            </a:lvl1pPr>
            <a:lvl2pPr>
              <a:defRPr sz="1621"/>
            </a:lvl2pPr>
            <a:lvl3pPr>
              <a:defRPr sz="1389"/>
            </a:lvl3pPr>
            <a:lvl4pPr>
              <a:defRPr sz="1157"/>
            </a:lvl4pPr>
            <a:lvl5pPr>
              <a:defRPr sz="1157"/>
            </a:lvl5pPr>
            <a:lvl6pPr>
              <a:defRPr sz="1157"/>
            </a:lvl6pPr>
            <a:lvl7pPr>
              <a:defRPr sz="1157"/>
            </a:lvl7pPr>
            <a:lvl8pPr>
              <a:defRPr sz="1157"/>
            </a:lvl8pPr>
            <a:lvl9pPr>
              <a:defRPr sz="1157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4564" y="2537937"/>
            <a:ext cx="1707042" cy="4701841"/>
          </a:xfrm>
        </p:spPr>
        <p:txBody>
          <a:bodyPr/>
          <a:lstStyle>
            <a:lvl1pPr marL="0" indent="0">
              <a:buNone/>
              <a:defRPr sz="925"/>
            </a:lvl1pPr>
            <a:lvl2pPr marL="264617" indent="0">
              <a:buNone/>
              <a:defRPr sz="810"/>
            </a:lvl2pPr>
            <a:lvl3pPr marL="529233" indent="0">
              <a:buNone/>
              <a:defRPr sz="695"/>
            </a:lvl3pPr>
            <a:lvl4pPr marL="793850" indent="0">
              <a:buNone/>
              <a:defRPr sz="579"/>
            </a:lvl4pPr>
            <a:lvl5pPr marL="1058465" indent="0">
              <a:buNone/>
              <a:defRPr sz="579"/>
            </a:lvl5pPr>
            <a:lvl6pPr marL="1323084" indent="0">
              <a:buNone/>
              <a:defRPr sz="579"/>
            </a:lvl6pPr>
            <a:lvl7pPr marL="1587699" indent="0">
              <a:buNone/>
              <a:defRPr sz="579"/>
            </a:lvl7pPr>
            <a:lvl8pPr marL="1852315" indent="0">
              <a:buNone/>
              <a:defRPr sz="579"/>
            </a:lvl8pPr>
            <a:lvl9pPr marL="2116932" indent="0">
              <a:buNone/>
              <a:defRPr sz="579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74062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564" y="563988"/>
            <a:ext cx="1707042" cy="1973950"/>
          </a:xfrm>
        </p:spPr>
        <p:txBody>
          <a:bodyPr anchor="b"/>
          <a:lstStyle>
            <a:lvl1pPr>
              <a:defRPr sz="185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50098" y="1218056"/>
            <a:ext cx="2679442" cy="6011932"/>
          </a:xfrm>
        </p:spPr>
        <p:txBody>
          <a:bodyPr anchor="t"/>
          <a:lstStyle>
            <a:lvl1pPr marL="0" indent="0">
              <a:buNone/>
              <a:defRPr sz="1853"/>
            </a:lvl1pPr>
            <a:lvl2pPr marL="264617" indent="0">
              <a:buNone/>
              <a:defRPr sz="1621"/>
            </a:lvl2pPr>
            <a:lvl3pPr marL="529233" indent="0">
              <a:buNone/>
              <a:defRPr sz="1389"/>
            </a:lvl3pPr>
            <a:lvl4pPr marL="793850" indent="0">
              <a:buNone/>
              <a:defRPr sz="1157"/>
            </a:lvl4pPr>
            <a:lvl5pPr marL="1058465" indent="0">
              <a:buNone/>
              <a:defRPr sz="1157"/>
            </a:lvl5pPr>
            <a:lvl6pPr marL="1323084" indent="0">
              <a:buNone/>
              <a:defRPr sz="1157"/>
            </a:lvl6pPr>
            <a:lvl7pPr marL="1587699" indent="0">
              <a:buNone/>
              <a:defRPr sz="1157"/>
            </a:lvl7pPr>
            <a:lvl8pPr marL="1852315" indent="0">
              <a:buNone/>
              <a:defRPr sz="1157"/>
            </a:lvl8pPr>
            <a:lvl9pPr marL="2116932" indent="0">
              <a:buNone/>
              <a:defRPr sz="1157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4564" y="2537937"/>
            <a:ext cx="1707042" cy="4701841"/>
          </a:xfrm>
        </p:spPr>
        <p:txBody>
          <a:bodyPr/>
          <a:lstStyle>
            <a:lvl1pPr marL="0" indent="0">
              <a:buNone/>
              <a:defRPr sz="925"/>
            </a:lvl1pPr>
            <a:lvl2pPr marL="264617" indent="0">
              <a:buNone/>
              <a:defRPr sz="810"/>
            </a:lvl2pPr>
            <a:lvl3pPr marL="529233" indent="0">
              <a:buNone/>
              <a:defRPr sz="695"/>
            </a:lvl3pPr>
            <a:lvl4pPr marL="793850" indent="0">
              <a:buNone/>
              <a:defRPr sz="579"/>
            </a:lvl4pPr>
            <a:lvl5pPr marL="1058465" indent="0">
              <a:buNone/>
              <a:defRPr sz="579"/>
            </a:lvl5pPr>
            <a:lvl6pPr marL="1323084" indent="0">
              <a:buNone/>
              <a:defRPr sz="579"/>
            </a:lvl6pPr>
            <a:lvl7pPr marL="1587699" indent="0">
              <a:buNone/>
              <a:defRPr sz="579"/>
            </a:lvl7pPr>
            <a:lvl8pPr marL="1852315" indent="0">
              <a:buNone/>
              <a:defRPr sz="579"/>
            </a:lvl8pPr>
            <a:lvl9pPr marL="2116932" indent="0">
              <a:buNone/>
              <a:defRPr sz="579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008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3876" y="450406"/>
            <a:ext cx="4564975" cy="16351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3876" y="2252027"/>
            <a:ext cx="4564975" cy="53676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3876" y="7840974"/>
            <a:ext cx="1190863" cy="450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F094F6-2972-4C39-9985-90C3B7998B31}" type="datetimeFigureOut">
              <a:rPr lang="fr-FR" smtClean="0"/>
              <a:t>07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53216" y="7840974"/>
            <a:ext cx="1786295" cy="450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37987" y="7840974"/>
            <a:ext cx="1190863" cy="450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7522A-F354-43BA-8528-3F075C54151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7172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29233" rtl="0" eaLnBrk="1" latinLnBrk="0" hangingPunct="1">
        <a:lnSpc>
          <a:spcPct val="90000"/>
        </a:lnSpc>
        <a:spcBef>
          <a:spcPct val="0"/>
        </a:spcBef>
        <a:buNone/>
        <a:defRPr sz="25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2309" indent="-132309" algn="l" defTabSz="529233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1621" kern="1200">
          <a:solidFill>
            <a:schemeClr val="tx1"/>
          </a:solidFill>
          <a:latin typeface="+mn-lt"/>
          <a:ea typeface="+mn-ea"/>
          <a:cs typeface="+mn-cs"/>
        </a:defRPr>
      </a:lvl1pPr>
      <a:lvl2pPr marL="396924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389" kern="1200">
          <a:solidFill>
            <a:schemeClr val="tx1"/>
          </a:solidFill>
          <a:latin typeface="+mn-lt"/>
          <a:ea typeface="+mn-ea"/>
          <a:cs typeface="+mn-cs"/>
        </a:defRPr>
      </a:lvl2pPr>
      <a:lvl3pPr marL="661541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157" kern="1200">
          <a:solidFill>
            <a:schemeClr val="tx1"/>
          </a:solidFill>
          <a:latin typeface="+mn-lt"/>
          <a:ea typeface="+mn-ea"/>
          <a:cs typeface="+mn-cs"/>
        </a:defRPr>
      </a:lvl3pPr>
      <a:lvl4pPr marL="926158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4pPr>
      <a:lvl5pPr marL="1190774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5pPr>
      <a:lvl6pPr marL="1455391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6pPr>
      <a:lvl7pPr marL="1720008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7pPr>
      <a:lvl8pPr marL="1984623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8pPr>
      <a:lvl9pPr marL="2249241" indent="-132309" algn="l" defTabSz="52923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1pPr>
      <a:lvl2pPr marL="264617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2pPr>
      <a:lvl3pPr marL="529233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3pPr>
      <a:lvl4pPr marL="793850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4pPr>
      <a:lvl5pPr marL="1058465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5pPr>
      <a:lvl6pPr marL="1323084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6pPr>
      <a:lvl7pPr marL="1587699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7pPr>
      <a:lvl8pPr marL="1852315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8pPr>
      <a:lvl9pPr marL="2116932" algn="l" defTabSz="529233" rtl="0" eaLnBrk="1" latinLnBrk="0" hangingPunct="1">
        <a:defRPr sz="10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ZoneTexte 20">
            <a:extLst>
              <a:ext uri="{FF2B5EF4-FFF2-40B4-BE49-F238E27FC236}">
                <a16:creationId xmlns:a16="http://schemas.microsoft.com/office/drawing/2014/main" id="{4590C627-070E-4286-BA4A-7E96BD47F00A}"/>
              </a:ext>
            </a:extLst>
          </p:cNvPr>
          <p:cNvSpPr txBox="1"/>
          <p:nvPr/>
        </p:nvSpPr>
        <p:spPr>
          <a:xfrm>
            <a:off x="-39543" y="0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ICM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D7CCB3DC-A60F-49C2-B8C6-12809985AD16}"/>
              </a:ext>
            </a:extLst>
          </p:cNvPr>
          <p:cNvSpPr txBox="1"/>
          <p:nvPr/>
        </p:nvSpPr>
        <p:spPr>
          <a:xfrm>
            <a:off x="-39543" y="3982464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TE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82F84FAC-ED56-4F9F-9276-FCD123327E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1373" y="-3267"/>
            <a:ext cx="2769977" cy="2668411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AD3764BB-182B-481A-9EEB-477BA12687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1372" y="4144265"/>
            <a:ext cx="2769977" cy="2668411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CCDAF992-8A6F-4D93-B78B-9A0C5CD5E6C9}"/>
              </a:ext>
            </a:extLst>
          </p:cNvPr>
          <p:cNvSpPr txBox="1"/>
          <p:nvPr/>
        </p:nvSpPr>
        <p:spPr>
          <a:xfrm>
            <a:off x="2070679" y="2245985"/>
            <a:ext cx="1151362" cy="1446550"/>
          </a:xfrm>
          <a:prstGeom prst="rect">
            <a:avLst/>
          </a:prstGeom>
          <a:noFill/>
          <a:ln w="38100">
            <a:solidFill>
              <a:srgbClr val="FCB4CB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FR" sz="800" dirty="0"/>
              <a:t>ENSECAG00000011960</a:t>
            </a:r>
          </a:p>
          <a:p>
            <a:pPr algn="ctr"/>
            <a:r>
              <a:rPr lang="fr-FR" sz="800" dirty="0"/>
              <a:t>ENSECAG00000022277</a:t>
            </a:r>
          </a:p>
          <a:p>
            <a:pPr algn="ctr"/>
            <a:r>
              <a:rPr lang="fr-FR" sz="800" dirty="0"/>
              <a:t>ENSECAG00000019702</a:t>
            </a:r>
          </a:p>
          <a:p>
            <a:pPr algn="ctr"/>
            <a:r>
              <a:rPr lang="fr-FR" sz="800" dirty="0"/>
              <a:t>ENSECAG00000034815</a:t>
            </a:r>
          </a:p>
          <a:p>
            <a:pPr algn="ctr"/>
            <a:r>
              <a:rPr lang="fr-FR" sz="800" dirty="0"/>
              <a:t>ENSECAG00000029895</a:t>
            </a:r>
          </a:p>
          <a:p>
            <a:pPr algn="ctr"/>
            <a:r>
              <a:rPr lang="fr-FR" sz="800" dirty="0"/>
              <a:t>ENSECAG00000030975</a:t>
            </a:r>
          </a:p>
          <a:p>
            <a:pPr algn="ctr"/>
            <a:r>
              <a:rPr lang="fr-FR" sz="800" dirty="0"/>
              <a:t>ENSECAG00000030251</a:t>
            </a:r>
          </a:p>
          <a:p>
            <a:pPr algn="ctr"/>
            <a:r>
              <a:rPr lang="fr-FR" sz="800" dirty="0"/>
              <a:t>ENSECAG00000004931</a:t>
            </a:r>
          </a:p>
          <a:p>
            <a:pPr algn="ctr"/>
            <a:r>
              <a:rPr lang="fr-FR" sz="800" dirty="0"/>
              <a:t>ENSECAG00000009590</a:t>
            </a:r>
          </a:p>
          <a:p>
            <a:pPr algn="ctr"/>
            <a:r>
              <a:rPr lang="fr-FR" sz="800" dirty="0"/>
              <a:t>ENSECAG00000017619</a:t>
            </a:r>
          </a:p>
          <a:p>
            <a:pPr algn="ctr"/>
            <a:r>
              <a:rPr lang="fr-FR" sz="800" dirty="0"/>
              <a:t>ENSECAG00000010385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DC26EB0-536E-49E6-8B4A-57D4395224E1}"/>
              </a:ext>
            </a:extLst>
          </p:cNvPr>
          <p:cNvSpPr txBox="1"/>
          <p:nvPr/>
        </p:nvSpPr>
        <p:spPr>
          <a:xfrm>
            <a:off x="4091900" y="915439"/>
            <a:ext cx="1151363" cy="830997"/>
          </a:xfrm>
          <a:prstGeom prst="rect">
            <a:avLst/>
          </a:prstGeom>
          <a:noFill/>
          <a:ln w="38100">
            <a:solidFill>
              <a:srgbClr val="FBDDCE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FR" sz="800" dirty="0"/>
              <a:t>ENSECAG00000010447</a:t>
            </a:r>
          </a:p>
          <a:p>
            <a:pPr algn="ctr"/>
            <a:r>
              <a:rPr lang="fr-FR" sz="800" dirty="0"/>
              <a:t>ENSECAG00000007262</a:t>
            </a:r>
          </a:p>
          <a:p>
            <a:pPr algn="ctr"/>
            <a:r>
              <a:rPr lang="fr-FR" sz="800" dirty="0"/>
              <a:t>ENSECAG00000020433</a:t>
            </a:r>
          </a:p>
          <a:p>
            <a:pPr algn="ctr"/>
            <a:r>
              <a:rPr lang="fr-FR" sz="800" dirty="0"/>
              <a:t>ENSECAG00000014243</a:t>
            </a:r>
          </a:p>
          <a:p>
            <a:pPr algn="ctr"/>
            <a:r>
              <a:rPr lang="fr-FR" sz="800" dirty="0"/>
              <a:t>ENSECAG00000015867</a:t>
            </a:r>
          </a:p>
          <a:p>
            <a:pPr algn="ctr"/>
            <a:r>
              <a:rPr lang="fr-FR" sz="800" dirty="0"/>
              <a:t>ENSECAG00000041817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D291EB7-68E6-416C-B388-3FA11C231CA9}"/>
              </a:ext>
            </a:extLst>
          </p:cNvPr>
          <p:cNvSpPr txBox="1"/>
          <p:nvPr/>
        </p:nvSpPr>
        <p:spPr>
          <a:xfrm>
            <a:off x="2070679" y="6458733"/>
            <a:ext cx="1151362" cy="707886"/>
          </a:xfrm>
          <a:prstGeom prst="rect">
            <a:avLst/>
          </a:prstGeom>
          <a:noFill/>
          <a:ln w="38100">
            <a:solidFill>
              <a:srgbClr val="FCB4CB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nl-NL" sz="800" dirty="0"/>
              <a:t>ENSECAG00000012493</a:t>
            </a:r>
          </a:p>
          <a:p>
            <a:pPr algn="ctr"/>
            <a:r>
              <a:rPr lang="nl-NL" sz="800" dirty="0"/>
              <a:t>ENSECAG00000038654</a:t>
            </a:r>
          </a:p>
          <a:p>
            <a:pPr algn="ctr"/>
            <a:r>
              <a:rPr lang="nl-NL" sz="800" dirty="0"/>
              <a:t>ENSECAG00000008177</a:t>
            </a:r>
          </a:p>
          <a:p>
            <a:pPr algn="ctr"/>
            <a:r>
              <a:rPr lang="nl-NL" sz="800" dirty="0"/>
              <a:t>ENSECAG00000018727</a:t>
            </a:r>
          </a:p>
          <a:p>
            <a:pPr algn="ctr"/>
            <a:r>
              <a:rPr lang="nl-NL" sz="800" dirty="0"/>
              <a:t>ENSECAG00000020415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C746AA4B-D922-44C0-B306-D4687B552FBE}"/>
              </a:ext>
            </a:extLst>
          </p:cNvPr>
          <p:cNvSpPr txBox="1"/>
          <p:nvPr/>
        </p:nvSpPr>
        <p:spPr>
          <a:xfrm>
            <a:off x="110010" y="5370748"/>
            <a:ext cx="1151362" cy="215444"/>
          </a:xfrm>
          <a:prstGeom prst="rect">
            <a:avLst/>
          </a:prstGeom>
          <a:noFill/>
          <a:ln w="38100">
            <a:solidFill>
              <a:srgbClr val="FFCFF2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FR" sz="800" dirty="0"/>
              <a:t>ENSECAG00000012554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1B4DFF0F-C7CE-4969-85BC-EFD0E8577FA9}"/>
              </a:ext>
            </a:extLst>
          </p:cNvPr>
          <p:cNvSpPr txBox="1"/>
          <p:nvPr/>
        </p:nvSpPr>
        <p:spPr>
          <a:xfrm>
            <a:off x="4026493" y="5370748"/>
            <a:ext cx="1151362" cy="215444"/>
          </a:xfrm>
          <a:prstGeom prst="rect">
            <a:avLst/>
          </a:prstGeom>
          <a:noFill/>
          <a:ln w="38100">
            <a:solidFill>
              <a:srgbClr val="FBDDCE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fr-FR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NSECAG00000012554</a:t>
            </a:r>
            <a:r>
              <a:rPr lang="fr-FR" sz="8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741183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419</TotalTime>
  <Words>26</Words>
  <Application>Microsoft Office PowerPoint</Application>
  <PresentationFormat>Personnalisé</PresentationFormat>
  <Paragraphs>2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ilie Derisoud</dc:creator>
  <cp:lastModifiedBy>Emilie Derisoud</cp:lastModifiedBy>
  <cp:revision>10</cp:revision>
  <dcterms:created xsi:type="dcterms:W3CDTF">2021-09-12T16:42:16Z</dcterms:created>
  <dcterms:modified xsi:type="dcterms:W3CDTF">2022-01-07T10:19:27Z</dcterms:modified>
</cp:coreProperties>
</file>